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  <p:sldId id="260" r:id="rId4"/>
    <p:sldId id="256" r:id="rId5"/>
    <p:sldId id="261" r:id="rId6"/>
  </p:sldIdLst>
  <p:sldSz cx="9144000" cy="6858000" type="screen4x3"/>
  <p:notesSz cx="6735763" cy="98663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4" d="100"/>
          <a:sy n="84" d="100"/>
        </p:scale>
        <p:origin x="-1402" y="-6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6B8EA-3EA4-4C41-9ADB-2C501BDABC90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C9CC3-4983-4C75-B820-FDB43A271E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444594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6B8EA-3EA4-4C41-9ADB-2C501BDABC90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C9CC3-4983-4C75-B820-FDB43A271E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224884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6B8EA-3EA4-4C41-9ADB-2C501BDABC90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C9CC3-4983-4C75-B820-FDB43A271E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169311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6B8EA-3EA4-4C41-9ADB-2C501BDABC90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C9CC3-4983-4C75-B820-FDB43A271E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131474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6B8EA-3EA4-4C41-9ADB-2C501BDABC90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C9CC3-4983-4C75-B820-FDB43A271E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106594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6B8EA-3EA4-4C41-9ADB-2C501BDABC90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C9CC3-4983-4C75-B820-FDB43A271E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290506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6B8EA-3EA4-4C41-9ADB-2C501BDABC90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C9CC3-4983-4C75-B820-FDB43A271E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022320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6B8EA-3EA4-4C41-9ADB-2C501BDABC90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C9CC3-4983-4C75-B820-FDB43A271E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219751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6B8EA-3EA4-4C41-9ADB-2C501BDABC90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C9CC3-4983-4C75-B820-FDB43A271E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389294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6B8EA-3EA4-4C41-9ADB-2C501BDABC90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C9CC3-4983-4C75-B820-FDB43A271E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470058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6B8EA-3EA4-4C41-9ADB-2C501BDABC90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C9CC3-4983-4C75-B820-FDB43A271E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327792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A6B8EA-3EA4-4C41-9ADB-2C501BDABC90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6C9CC3-4983-4C75-B820-FDB43A271E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010335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1062" y="885825"/>
            <a:ext cx="7381875" cy="5086350"/>
          </a:xfrm>
          <a:prstGeom prst="rect">
            <a:avLst/>
          </a:prstGeom>
        </p:spPr>
      </p:pic>
      <p:sp>
        <p:nvSpPr>
          <p:cNvPr id="4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AU" sz="2000" dirty="0" smtClean="0"/>
              <a:t>Fig. S7 </a:t>
            </a:r>
            <a:r>
              <a:rPr lang="en-AU" sz="2000" dirty="0" smtClean="0"/>
              <a:t>(A). </a:t>
            </a:r>
            <a:r>
              <a:rPr lang="en-AU" sz="2000" dirty="0"/>
              <a:t>Frequency </a:t>
            </a:r>
            <a:r>
              <a:rPr lang="en-AU" sz="2000" dirty="0" smtClean="0"/>
              <a:t>distribution of shoot biomass in a </a:t>
            </a:r>
            <a:r>
              <a:rPr lang="en-AU" sz="2000" dirty="0" err="1" smtClean="0"/>
              <a:t>SAgS</a:t>
            </a:r>
            <a:r>
              <a:rPr lang="en-AU" sz="2000" dirty="0" smtClean="0"/>
              <a:t> DH population </a:t>
            </a:r>
            <a:r>
              <a:rPr lang="en-AU" sz="2000" dirty="0" err="1" smtClean="0"/>
              <a:t>phenotyped</a:t>
            </a:r>
            <a:r>
              <a:rPr lang="en-AU" sz="2000" dirty="0" smtClean="0"/>
              <a:t> across 2014-2016 growing environments. </a:t>
            </a:r>
            <a:endParaRPr lang="en-AU" sz="2000" dirty="0"/>
          </a:p>
        </p:txBody>
      </p:sp>
    </p:spTree>
    <p:extLst>
      <p:ext uri="{BB962C8B-B14F-4D97-AF65-F5344CB8AC3E}">
        <p14:creationId xmlns:p14="http://schemas.microsoft.com/office/powerpoint/2010/main" val="19975212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AU" sz="2000" dirty="0" smtClean="0"/>
              <a:t>Fig. S7 </a:t>
            </a:r>
            <a:r>
              <a:rPr lang="en-AU" sz="2000" dirty="0" smtClean="0"/>
              <a:t>(B). </a:t>
            </a:r>
            <a:r>
              <a:rPr lang="en-AU" sz="2000" dirty="0"/>
              <a:t>Frequency </a:t>
            </a:r>
            <a:r>
              <a:rPr lang="en-AU" sz="2000" dirty="0" smtClean="0"/>
              <a:t>distribution of fractional ground cover, measured as NDVI with a hand-held </a:t>
            </a:r>
            <a:r>
              <a:rPr lang="en-AU" sz="2000" dirty="0" err="1" smtClean="0"/>
              <a:t>GreenSeeker</a:t>
            </a:r>
            <a:r>
              <a:rPr lang="en-AU" sz="2000" dirty="0" smtClean="0"/>
              <a:t> machine, in a </a:t>
            </a:r>
            <a:r>
              <a:rPr lang="en-AU" sz="2000" dirty="0" err="1" smtClean="0"/>
              <a:t>SAgS</a:t>
            </a:r>
            <a:r>
              <a:rPr lang="en-AU" sz="2000" dirty="0" smtClean="0"/>
              <a:t> DH population </a:t>
            </a:r>
            <a:r>
              <a:rPr lang="en-AU" sz="2000" dirty="0" err="1" smtClean="0"/>
              <a:t>phenotyped</a:t>
            </a:r>
            <a:r>
              <a:rPr lang="en-AU" sz="2000" dirty="0" smtClean="0"/>
              <a:t> across 2015-2016 growing environments. </a:t>
            </a:r>
            <a:endParaRPr lang="en-AU" sz="2000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3568" y="1412776"/>
            <a:ext cx="7381875" cy="50863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188785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AU" sz="1800" dirty="0" smtClean="0"/>
              <a:t>Fig. S7 </a:t>
            </a:r>
            <a:r>
              <a:rPr lang="en-AU" sz="1800" dirty="0" smtClean="0"/>
              <a:t>(C). Frequency distribution of days to flower in a </a:t>
            </a:r>
            <a:r>
              <a:rPr lang="en-AU" sz="1800" dirty="0" err="1" smtClean="0"/>
              <a:t>SAgS</a:t>
            </a:r>
            <a:r>
              <a:rPr lang="en-AU" sz="1800" dirty="0" smtClean="0"/>
              <a:t> DH population </a:t>
            </a:r>
            <a:r>
              <a:rPr lang="en-AU" sz="1800" dirty="0" err="1" smtClean="0"/>
              <a:t>phenotyped</a:t>
            </a:r>
            <a:r>
              <a:rPr lang="en-AU" sz="1800" dirty="0" smtClean="0"/>
              <a:t> across four environments (2013-2016). Phenotypic data of 2013 and 2014 was published previously [13]</a:t>
            </a:r>
            <a:endParaRPr lang="en-AU" sz="1800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1560" y="1556792"/>
            <a:ext cx="7381875" cy="50863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716186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9045" y="1412776"/>
            <a:ext cx="7381875" cy="5086350"/>
          </a:xfrm>
          <a:prstGeom prst="rect">
            <a:avLst/>
          </a:prstGeom>
        </p:spPr>
      </p:pic>
      <p:sp>
        <p:nvSpPr>
          <p:cNvPr id="6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AU" sz="2000" dirty="0" smtClean="0"/>
              <a:t>Fig. S7 </a:t>
            </a:r>
            <a:r>
              <a:rPr lang="en-AU" sz="2000" dirty="0"/>
              <a:t>(D). Frequency </a:t>
            </a:r>
            <a:r>
              <a:rPr lang="en-AU" sz="2000" dirty="0" smtClean="0"/>
              <a:t>distribution of plant height and plant emergence in a </a:t>
            </a:r>
            <a:r>
              <a:rPr lang="en-AU" sz="2000" dirty="0" err="1" smtClean="0"/>
              <a:t>SAgS</a:t>
            </a:r>
            <a:r>
              <a:rPr lang="en-AU" sz="2000" dirty="0" smtClean="0"/>
              <a:t> DH population </a:t>
            </a:r>
            <a:r>
              <a:rPr lang="en-AU" sz="2000" dirty="0" err="1" smtClean="0"/>
              <a:t>phenotyped</a:t>
            </a:r>
            <a:r>
              <a:rPr lang="en-AU" sz="2000" dirty="0" smtClean="0"/>
              <a:t> in 2016 growing environments. </a:t>
            </a:r>
            <a:endParaRPr lang="en-AU" sz="2000" dirty="0"/>
          </a:p>
        </p:txBody>
      </p:sp>
    </p:spTree>
    <p:extLst>
      <p:ext uri="{BB962C8B-B14F-4D97-AF65-F5344CB8AC3E}">
        <p14:creationId xmlns:p14="http://schemas.microsoft.com/office/powerpoint/2010/main" val="225603080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6840" y="1340768"/>
            <a:ext cx="7381875" cy="5086350"/>
          </a:xfrm>
          <a:prstGeom prst="rect">
            <a:avLst/>
          </a:prstGeom>
        </p:spPr>
      </p:pic>
      <p:sp>
        <p:nvSpPr>
          <p:cNvPr id="4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AU" sz="1800" smtClean="0"/>
              <a:t>Fig</a:t>
            </a:r>
            <a:r>
              <a:rPr lang="en-AU" sz="1800" dirty="0" smtClean="0"/>
              <a:t>. S7 </a:t>
            </a:r>
            <a:r>
              <a:rPr lang="en-AU" sz="1800" dirty="0" smtClean="0"/>
              <a:t>(E). </a:t>
            </a:r>
            <a:r>
              <a:rPr lang="en-AU" sz="1800" dirty="0"/>
              <a:t>Frequency </a:t>
            </a:r>
            <a:r>
              <a:rPr lang="en-AU" sz="1800" dirty="0" smtClean="0"/>
              <a:t>distribution of grain yield in a </a:t>
            </a:r>
            <a:r>
              <a:rPr lang="en-AU" sz="1800" dirty="0" err="1" smtClean="0"/>
              <a:t>SAgS</a:t>
            </a:r>
            <a:r>
              <a:rPr lang="en-AU" sz="1800" dirty="0" smtClean="0"/>
              <a:t> DH population </a:t>
            </a:r>
            <a:r>
              <a:rPr lang="en-AU" sz="1800" dirty="0" err="1" smtClean="0"/>
              <a:t>phenotyped</a:t>
            </a:r>
            <a:r>
              <a:rPr lang="en-AU" sz="1800" dirty="0" smtClean="0"/>
              <a:t> across four environments (2013-2016). Phenotypic data of 2013 and 2014 experiments was published previously </a:t>
            </a:r>
            <a:r>
              <a:rPr lang="en-AU" sz="1800" dirty="0"/>
              <a:t>[</a:t>
            </a:r>
            <a:r>
              <a:rPr lang="en-AU" sz="1800" dirty="0" smtClean="0"/>
              <a:t>13].</a:t>
            </a:r>
            <a:endParaRPr lang="en-AU" sz="1800" dirty="0"/>
          </a:p>
        </p:txBody>
      </p:sp>
    </p:spTree>
    <p:extLst>
      <p:ext uri="{BB962C8B-B14F-4D97-AF65-F5344CB8AC3E}">
        <p14:creationId xmlns:p14="http://schemas.microsoft.com/office/powerpoint/2010/main" val="16944717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3</TotalTime>
  <Words>152</Words>
  <Application>Microsoft Office PowerPoint</Application>
  <PresentationFormat>On-screen Show (4:3)</PresentationFormat>
  <Paragraphs>5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Fig. S7 (A). Frequency distribution of shoot biomass in a SAgS DH population phenotyped across 2014-2016 growing environments. </vt:lpstr>
      <vt:lpstr>Fig. S7 (B). Frequency distribution of fractional ground cover, measured as NDVI with a hand-held GreenSeeker machine, in a SAgS DH population phenotyped across 2015-2016 growing environments. </vt:lpstr>
      <vt:lpstr>Fig. S7 (C). Frequency distribution of days to flower in a SAgS DH population phenotyped across four environments (2013-2016). Phenotypic data of 2013 and 2014 was published previously [13]</vt:lpstr>
      <vt:lpstr>Fig. S7 (D). Frequency distribution of plant height and plant emergence in a SAgS DH population phenotyped in 2016 growing environments. </vt:lpstr>
      <vt:lpstr>Fig. S7 (E). Frequency distribution of grain yield in a SAgS DH population phenotyped across four environments (2013-2016). Phenotypic data of 2013 and 2014 experiments was published previously [13].</vt:lpstr>
    </vt:vector>
  </TitlesOfParts>
  <Company>NSW Governmen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SW Government User</dc:creator>
  <cp:lastModifiedBy>NSW Government User</cp:lastModifiedBy>
  <cp:revision>16</cp:revision>
  <cp:lastPrinted>2018-08-28T07:29:50Z</cp:lastPrinted>
  <dcterms:created xsi:type="dcterms:W3CDTF">2018-06-18T05:29:42Z</dcterms:created>
  <dcterms:modified xsi:type="dcterms:W3CDTF">2019-07-18T00:33:00Z</dcterms:modified>
</cp:coreProperties>
</file>